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41"/>
    <p:restoredTop sz="94604"/>
  </p:normalViewPr>
  <p:slideViewPr>
    <p:cSldViewPr snapToGrid="0">
      <p:cViewPr varScale="1">
        <p:scale>
          <a:sx n="80" d="100"/>
          <a:sy n="80" d="100"/>
        </p:scale>
        <p:origin x="56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478C79-BF72-A3EC-397A-CEABF9DB17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C943754-6A04-F150-BB47-D4B6E3A760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D06F7A-EBFB-23B1-186C-D1B7DE151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1B4D214-1EEC-379B-0745-9C73E90B0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4C758D-2F8E-8D76-CCE5-0BECD7ED27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34105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93720E-E5D4-93B3-00F4-F9564CF8E7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CAE688A-EA45-E2C9-85C1-0D54FB8F86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3D0CE7-5A34-D658-FB8B-2892C70E5D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270F0C-DEEA-66CC-DC81-19E48F4B7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23D6F4-6A30-6C32-AA63-86D04C4C74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26005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5AB0781-66EB-E2D1-7D2D-741AE47790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BBF1EDE-AB53-DD02-A936-3162D22049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FD00AD-E86D-251A-A074-3641714A6C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EBD693-DE72-3295-6C49-34B0986FB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F0C2FF-A2D8-06D3-87D9-79B51C8BF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79323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3F6222-2478-99E8-80E7-A96E7DED8F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680BB66-F096-8D7F-43AB-1F25E00CE9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FEA03D-8A0A-F6C4-5059-B5CAC740B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B21B1C-977C-26D2-CC4E-769FCB21E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F7847C-95E5-CD32-9AE4-111E8A11C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73277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4698B3-ACF0-6C4C-76FD-B6904EB20F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4D265CF-243A-C364-8724-13D7CE704E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B958DC-8558-F7ED-DB13-33FADB228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B7041C-1832-E76C-F87D-A47100741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13D394-29F3-9B2E-708F-E1E727542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42605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8846BE-61B7-5E4A-8D14-534F06B176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1CD4687-4A2F-B9DE-E9CA-18E6BEFB7E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17079B5-E9D1-2519-AA43-05EA2A7459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42DFA1-BFA4-AB15-2574-98E501127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75DE9BD-7468-C782-749A-E128E63EB5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AC705C8-BAE5-2E21-9CCE-D91E82A0A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94242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8393AB-ABC5-5E34-2C8A-0844D07470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72EA6AC-73DA-03AC-2D11-0F804BE3F8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2E9AE94-5055-CCE8-D549-605931758F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DB502F6-941A-FD5B-ECBA-1843E81B84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AA57CBD-0FDC-48FA-D5BB-4F609209A5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62D3FD1-1BD3-AFFD-483E-9BD85F8E2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6CCA939-3664-65FC-8CA3-E93DF4A7E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3CEC9D6-571B-A18C-1D2D-5405753DA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83022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99E566-B831-363A-2A2B-390ADCEDAC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B8853FC-2AD2-CED7-4D6E-0DE6218189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F26C258-FD98-AC75-0A90-4CBF82A2A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4611373-67D7-BC18-98D8-5EE5B78AC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34552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2EFE87B-F9B4-E058-4FDF-4B53245EF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DD58AB2-D82A-281A-4D1B-7879BBCC24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8028246-4A4A-82D9-5CFD-5D7271FA8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033374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1B349C-4981-4445-4013-3F1585C7FE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1FEDAE8-6A2C-F05C-29C8-FAADFF1A07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8204231-4670-3E4B-8280-3FA1648834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DF847A7-6242-7CB1-A9F3-8342DAAC0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2F28413-B650-79AB-E67B-588BCBEA2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CE4CD5A-41B2-B100-4C93-626F74F8FB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50217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A5E0D3-8913-0482-9EC1-4D2A9A3FD9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40170AD-479A-E45B-AA0F-25271DF197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037E18C-C183-B0CA-85B2-BA4C643CE9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7B303FA-F281-8A8A-660D-4143FF440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7540259-0A30-1E50-9FAC-3D6D14875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0939DFB-059F-59CC-6DE8-B2F9E45FA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37757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DD87D3E-D2CF-8742-ED2A-633676EC6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BED2A70-73EA-CDC4-BC82-0D6891863D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E39F75-2E59-4490-F785-52A1C115D7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0497AA-C15D-5246-B6B7-BACC5D121D4F}" type="datetimeFigureOut">
              <a:rPr kumimoji="1" lang="zh-CN" altLang="en-US" smtClean="0"/>
              <a:t>2024/3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618465-0CB4-682D-3795-B6D14AE94D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0FD3B4-E699-9D38-68B7-AD662B8E5A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5647A-D3DD-9445-BBA9-914B19379AB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65968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gif"/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g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gif"/><Relationship Id="rId2" Type="http://schemas.openxmlformats.org/officeDocument/2006/relationships/image" Target="../media/image6.g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gif"/><Relationship Id="rId4" Type="http://schemas.openxmlformats.org/officeDocument/2006/relationships/image" Target="../media/image8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>
            <a:extLst>
              <a:ext uri="{FF2B5EF4-FFF2-40B4-BE49-F238E27FC236}">
                <a16:creationId xmlns:a16="http://schemas.microsoft.com/office/drawing/2014/main" id="{8A97F533-4970-2843-87E6-9BC2C1948329}"/>
              </a:ext>
            </a:extLst>
          </p:cNvPr>
          <p:cNvSpPr txBox="1"/>
          <p:nvPr/>
        </p:nvSpPr>
        <p:spPr>
          <a:xfrm>
            <a:off x="1731085" y="4344236"/>
            <a:ext cx="872983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b="1" kern="100" dirty="0">
                <a:solidFill>
                  <a:srgbClr val="0D0D0D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Video S1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: </a:t>
            </a:r>
            <a:r>
              <a:rPr lang="en-US" altLang="zh-CN" sz="1800" b="1" i="1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ubAR</a:t>
            </a:r>
            <a:r>
              <a:rPr lang="en-US" altLang="zh-CN" sz="1800" b="1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romotes EB3 tracked </a:t>
            </a:r>
            <a:r>
              <a:rPr lang="en-US" altLang="zh-CN" b="1" dirty="0">
                <a:solidFill>
                  <a:srgbClr val="0D0D0D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crotubule assembly at </a:t>
            </a:r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 slower growth rate</a:t>
            </a:r>
            <a:r>
              <a:rPr lang="en-US" altLang="zh-CN" b="1" dirty="0">
                <a:solidFill>
                  <a:srgbClr val="0D0D0D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Representative videos of the EB3 tracking behavior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CN" sz="1800" kern="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quantification of EB3 comet velocity 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at microtubule plus-ends in Hela cells expressing </a:t>
            </a:r>
            <a:r>
              <a:rPr lang="en-US" altLang="zh-CN" i="1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TubAR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 antisense (</a:t>
            </a:r>
            <a:r>
              <a:rPr lang="en-US" altLang="zh-CN" i="1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TubAR AS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, serving as a negative control) or </a:t>
            </a:r>
            <a:r>
              <a:rPr lang="en-US" altLang="zh-CN" i="1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TubAR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. </a:t>
            </a:r>
          </a:p>
        </p:txBody>
      </p: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1CC121C8-0786-79A1-FE42-40CC7648BFD7}"/>
              </a:ext>
            </a:extLst>
          </p:cNvPr>
          <p:cNvGrpSpPr/>
          <p:nvPr/>
        </p:nvGrpSpPr>
        <p:grpSpPr>
          <a:xfrm>
            <a:off x="3735364" y="1296715"/>
            <a:ext cx="4379086" cy="2615260"/>
            <a:chOff x="2457459" y="1137363"/>
            <a:chExt cx="4379086" cy="2615260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2F8ED940-504C-D0AD-74D9-8D5486C76F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4553" t="11429" r="9018" b="22143"/>
            <a:stretch/>
          </p:blipFill>
          <p:spPr>
            <a:xfrm>
              <a:off x="4676545" y="1592623"/>
              <a:ext cx="2160000" cy="2160000"/>
            </a:xfrm>
            <a:prstGeom prst="rect">
              <a:avLst/>
            </a:prstGeom>
          </p:spPr>
        </p:pic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6734F3DA-C174-0575-D06A-9E1936867E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2232" t="11429" r="21339" b="22143"/>
            <a:stretch/>
          </p:blipFill>
          <p:spPr>
            <a:xfrm>
              <a:off x="2471389" y="1592623"/>
              <a:ext cx="2160000" cy="2160000"/>
            </a:xfrm>
            <a:prstGeom prst="rect">
              <a:avLst/>
            </a:prstGeom>
          </p:spPr>
        </p:pic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791F2BC3-0AE7-6F6B-993A-BA480014AB39}"/>
                </a:ext>
              </a:extLst>
            </p:cNvPr>
            <p:cNvSpPr txBox="1"/>
            <p:nvPr/>
          </p:nvSpPr>
          <p:spPr>
            <a:xfrm>
              <a:off x="2471389" y="1604538"/>
              <a:ext cx="13131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B3-eGFP</a:t>
              </a:r>
              <a:endParaRPr kumimoji="1" lang="zh-CN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AAA0E344-0A37-0C13-FDF8-655BF9EB8AEE}"/>
                </a:ext>
              </a:extLst>
            </p:cNvPr>
            <p:cNvGrpSpPr/>
            <p:nvPr/>
          </p:nvGrpSpPr>
          <p:grpSpPr>
            <a:xfrm>
              <a:off x="2457459" y="1137363"/>
              <a:ext cx="2160000" cy="402772"/>
              <a:chOff x="2403657" y="454811"/>
              <a:chExt cx="2160000" cy="402772"/>
            </a:xfrm>
          </p:grpSpPr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0A7C9D61-BE03-990A-832D-3D714BADE87D}"/>
                  </a:ext>
                </a:extLst>
              </p:cNvPr>
              <p:cNvSpPr txBox="1"/>
              <p:nvPr/>
            </p:nvSpPr>
            <p:spPr>
              <a:xfrm>
                <a:off x="2833511" y="471531"/>
                <a:ext cx="130029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TubAR AS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A81B94E3-2ABF-6DA8-D77D-E2AC6A4597F5}"/>
                  </a:ext>
                </a:extLst>
              </p:cNvPr>
              <p:cNvSpPr/>
              <p:nvPr/>
            </p:nvSpPr>
            <p:spPr>
              <a:xfrm>
                <a:off x="2403657" y="454811"/>
                <a:ext cx="2160000" cy="4027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ACCD87B9-B926-C986-30BF-3892F32C0FD0}"/>
                </a:ext>
              </a:extLst>
            </p:cNvPr>
            <p:cNvGrpSpPr/>
            <p:nvPr/>
          </p:nvGrpSpPr>
          <p:grpSpPr>
            <a:xfrm>
              <a:off x="4665256" y="1137363"/>
              <a:ext cx="2160000" cy="402772"/>
              <a:chOff x="5961264" y="454811"/>
              <a:chExt cx="2160000" cy="402772"/>
            </a:xfrm>
          </p:grpSpPr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973D2F09-0ADC-45F9-A511-7C93EE8DF55A}"/>
                  </a:ext>
                </a:extLst>
              </p:cNvPr>
              <p:cNvSpPr txBox="1"/>
              <p:nvPr/>
            </p:nvSpPr>
            <p:spPr>
              <a:xfrm>
                <a:off x="6579182" y="471531"/>
                <a:ext cx="9241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TubAR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矩形 15">
                <a:extLst>
                  <a:ext uri="{FF2B5EF4-FFF2-40B4-BE49-F238E27FC236}">
                    <a16:creationId xmlns:a16="http://schemas.microsoft.com/office/drawing/2014/main" id="{9D7C710D-87D3-CD89-4776-C141E535357E}"/>
                  </a:ext>
                </a:extLst>
              </p:cNvPr>
              <p:cNvSpPr/>
              <p:nvPr/>
            </p:nvSpPr>
            <p:spPr>
              <a:xfrm>
                <a:off x="5961264" y="454811"/>
                <a:ext cx="2160000" cy="4027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" name="直线连接符 7">
              <a:extLst>
                <a:ext uri="{FF2B5EF4-FFF2-40B4-BE49-F238E27FC236}">
                  <a16:creationId xmlns:a16="http://schemas.microsoft.com/office/drawing/2014/main" id="{8E37BC48-B77B-F33A-A7C1-75B1027CCC7A}"/>
                </a:ext>
              </a:extLst>
            </p:cNvPr>
            <p:cNvCxnSpPr/>
            <p:nvPr/>
          </p:nvCxnSpPr>
          <p:spPr>
            <a:xfrm>
              <a:off x="6306696" y="3648067"/>
              <a:ext cx="3888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73DA07F6-FB45-3782-CBEB-D6FCEFAC6069}"/>
                </a:ext>
              </a:extLst>
            </p:cNvPr>
            <p:cNvSpPr txBox="1"/>
            <p:nvPr/>
          </p:nvSpPr>
          <p:spPr>
            <a:xfrm>
              <a:off x="6138850" y="3340290"/>
              <a:ext cx="6864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l-GR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μm</a:t>
              </a:r>
              <a:endParaRPr kumimoji="1"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Rectangle 2">
            <a:extLst>
              <a:ext uri="{FF2B5EF4-FFF2-40B4-BE49-F238E27FC236}">
                <a16:creationId xmlns:a16="http://schemas.microsoft.com/office/drawing/2014/main" id="{893340E1-8C09-9640-4C0B-6768D1E478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20150" y="104790"/>
            <a:ext cx="3150279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kern="0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等线 Light" panose="02010600030101010101" pitchFamily="2" charset="-122"/>
              </a:rPr>
              <a:t>Liang_Supplementary</a:t>
            </a:r>
            <a:r>
              <a:rPr lang="en-US" altLang="zh-CN" sz="1600" kern="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等线 Light" panose="02010600030101010101" pitchFamily="2" charset="-122"/>
              </a:rPr>
              <a:t> Video S1</a:t>
            </a:r>
          </a:p>
        </p:txBody>
      </p:sp>
    </p:spTree>
    <p:extLst>
      <p:ext uri="{BB962C8B-B14F-4D97-AF65-F5344CB8AC3E}">
        <p14:creationId xmlns:p14="http://schemas.microsoft.com/office/powerpoint/2010/main" val="35342867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>
            <a:extLst>
              <a:ext uri="{FF2B5EF4-FFF2-40B4-BE49-F238E27FC236}">
                <a16:creationId xmlns:a16="http://schemas.microsoft.com/office/drawing/2014/main" id="{68A46C9D-EEFB-8F9F-500D-52645785E66C}"/>
              </a:ext>
            </a:extLst>
          </p:cNvPr>
          <p:cNvSpPr txBox="1"/>
          <p:nvPr/>
        </p:nvSpPr>
        <p:spPr>
          <a:xfrm>
            <a:off x="1976963" y="4125822"/>
            <a:ext cx="829186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b="1" kern="100" dirty="0">
                <a:solidFill>
                  <a:srgbClr val="0D0D0D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Video S2: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UBA1A promotes EB3 tracked </a:t>
            </a:r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crotubule assembly at a slower growth rate. </a:t>
            </a:r>
            <a:endParaRPr lang="en-US" altLang="zh-CN" b="1" kern="1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Representative videos of the EB3 tracking behavior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CN" sz="1800" kern="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quantification of EB3 comet velocity 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at microtubule plus-ends in Hela cells expressing </a:t>
            </a:r>
            <a:r>
              <a:rPr lang="en-US" altLang="zh-CN" kern="100" dirty="0">
                <a:solidFill>
                  <a:srgbClr val="0D0D0D"/>
                </a:solidFill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siTUBA1As or siCtrl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. </a:t>
            </a:r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B2358989-220B-BA38-3D7C-9FC11F935A52}"/>
              </a:ext>
            </a:extLst>
          </p:cNvPr>
          <p:cNvGrpSpPr/>
          <p:nvPr/>
        </p:nvGrpSpPr>
        <p:grpSpPr>
          <a:xfrm>
            <a:off x="2841265" y="1368850"/>
            <a:ext cx="6555495" cy="2626748"/>
            <a:chOff x="1484266" y="1531387"/>
            <a:chExt cx="6555495" cy="2626748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FE4D6065-DD0F-D153-BF63-5A697AB2C2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3843" t="4520" r="16194" b="15460"/>
            <a:stretch/>
          </p:blipFill>
          <p:spPr>
            <a:xfrm>
              <a:off x="1484266" y="1998135"/>
              <a:ext cx="2160000" cy="2160000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39841093-C66E-831E-87FE-11755ECAFD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910" t="4735" r="17195" b="15445"/>
            <a:stretch/>
          </p:blipFill>
          <p:spPr>
            <a:xfrm>
              <a:off x="5879761" y="1998135"/>
              <a:ext cx="2160000" cy="2160000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445186D-1CE6-B967-70AC-28519272E6E2}"/>
                </a:ext>
              </a:extLst>
            </p:cNvPr>
            <p:cNvSpPr txBox="1"/>
            <p:nvPr/>
          </p:nvSpPr>
          <p:spPr>
            <a:xfrm>
              <a:off x="1503316" y="2009425"/>
              <a:ext cx="13131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B3-eGFP</a:t>
              </a:r>
              <a:endParaRPr kumimoji="1" lang="zh-CN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E7F6EFC0-586F-AAFF-2B56-0024D2B4C884}"/>
                </a:ext>
              </a:extLst>
            </p:cNvPr>
            <p:cNvGrpSpPr/>
            <p:nvPr/>
          </p:nvGrpSpPr>
          <p:grpSpPr>
            <a:xfrm>
              <a:off x="1503316" y="1531387"/>
              <a:ext cx="2160000" cy="402772"/>
              <a:chOff x="690516" y="1031754"/>
              <a:chExt cx="2160000" cy="402772"/>
            </a:xfrm>
          </p:grpSpPr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4B014265-DF53-EC64-F556-6404FC0DC7CE}"/>
                  </a:ext>
                </a:extLst>
              </p:cNvPr>
              <p:cNvSpPr txBox="1"/>
              <p:nvPr/>
            </p:nvSpPr>
            <p:spPr>
              <a:xfrm>
                <a:off x="1428115" y="1048474"/>
                <a:ext cx="71045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siCtrl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矩形 10">
                <a:extLst>
                  <a:ext uri="{FF2B5EF4-FFF2-40B4-BE49-F238E27FC236}">
                    <a16:creationId xmlns:a16="http://schemas.microsoft.com/office/drawing/2014/main" id="{BF6B89D7-6147-44AD-555B-A3A4E6057AEF}"/>
                  </a:ext>
                </a:extLst>
              </p:cNvPr>
              <p:cNvSpPr/>
              <p:nvPr/>
            </p:nvSpPr>
            <p:spPr>
              <a:xfrm>
                <a:off x="690516" y="1031754"/>
                <a:ext cx="2160000" cy="4027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01D677EE-317F-85F4-453C-50AC52EA8599}"/>
                </a:ext>
              </a:extLst>
            </p:cNvPr>
            <p:cNvGrpSpPr/>
            <p:nvPr/>
          </p:nvGrpSpPr>
          <p:grpSpPr>
            <a:xfrm>
              <a:off x="3685894" y="1531387"/>
              <a:ext cx="2160000" cy="402772"/>
              <a:chOff x="4425705" y="1031754"/>
              <a:chExt cx="2160000" cy="402772"/>
            </a:xfrm>
          </p:grpSpPr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64BF0698-4544-2B13-C482-9D6A7E909676}"/>
                  </a:ext>
                </a:extLst>
              </p:cNvPr>
              <p:cNvSpPr txBox="1"/>
              <p:nvPr/>
            </p:nvSpPr>
            <p:spPr>
              <a:xfrm>
                <a:off x="4857016" y="1065194"/>
                <a:ext cx="14542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siTUBA1A-1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CD6A45DD-7B8D-6523-B395-747409C21544}"/>
                  </a:ext>
                </a:extLst>
              </p:cNvPr>
              <p:cNvSpPr/>
              <p:nvPr/>
            </p:nvSpPr>
            <p:spPr>
              <a:xfrm>
                <a:off x="4425705" y="1031754"/>
                <a:ext cx="2160000" cy="4027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039B9CE9-BFEB-BBBA-8BC6-C68161EE7AA8}"/>
                </a:ext>
              </a:extLst>
            </p:cNvPr>
            <p:cNvGrpSpPr/>
            <p:nvPr/>
          </p:nvGrpSpPr>
          <p:grpSpPr>
            <a:xfrm>
              <a:off x="5879761" y="1531387"/>
              <a:ext cx="2160000" cy="402772"/>
              <a:chOff x="8109230" y="1031754"/>
              <a:chExt cx="2160000" cy="402772"/>
            </a:xfrm>
          </p:grpSpPr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1FC34C6F-2609-24B3-35F3-59F570723B46}"/>
                  </a:ext>
                </a:extLst>
              </p:cNvPr>
              <p:cNvSpPr txBox="1"/>
              <p:nvPr/>
            </p:nvSpPr>
            <p:spPr>
              <a:xfrm>
                <a:off x="8462108" y="1064058"/>
                <a:ext cx="14542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siTUBA1A-2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008AADBC-B2CD-CC30-A032-68D64C7A736E}"/>
                  </a:ext>
                </a:extLst>
              </p:cNvPr>
              <p:cNvSpPr/>
              <p:nvPr/>
            </p:nvSpPr>
            <p:spPr>
              <a:xfrm>
                <a:off x="8109230" y="1031754"/>
                <a:ext cx="2160000" cy="4027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C84D6ECC-A91E-6217-AD76-0C56A208F1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19980" r="20037"/>
            <a:stretch/>
          </p:blipFill>
          <p:spPr>
            <a:xfrm>
              <a:off x="3685894" y="1998135"/>
              <a:ext cx="2160000" cy="2160000"/>
            </a:xfrm>
            <a:prstGeom prst="rect">
              <a:avLst/>
            </a:prstGeom>
          </p:spPr>
        </p:pic>
        <p:cxnSp>
          <p:nvCxnSpPr>
            <p:cNvPr id="20" name="直线连接符 19">
              <a:extLst>
                <a:ext uri="{FF2B5EF4-FFF2-40B4-BE49-F238E27FC236}">
                  <a16:creationId xmlns:a16="http://schemas.microsoft.com/office/drawing/2014/main" id="{07472560-ABBD-70D4-8B3E-93398F27F4C8}"/>
                </a:ext>
              </a:extLst>
            </p:cNvPr>
            <p:cNvCxnSpPr/>
            <p:nvPr/>
          </p:nvCxnSpPr>
          <p:spPr>
            <a:xfrm>
              <a:off x="7521201" y="4048984"/>
              <a:ext cx="3888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DBA6D02C-0D74-4679-F4C3-CA1A4690C141}"/>
                </a:ext>
              </a:extLst>
            </p:cNvPr>
            <p:cNvSpPr txBox="1"/>
            <p:nvPr/>
          </p:nvSpPr>
          <p:spPr>
            <a:xfrm>
              <a:off x="7353355" y="3741207"/>
              <a:ext cx="6864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l-GR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μm</a:t>
              </a:r>
              <a:endParaRPr kumimoji="1"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Rectangle 2">
            <a:extLst>
              <a:ext uri="{FF2B5EF4-FFF2-40B4-BE49-F238E27FC236}">
                <a16:creationId xmlns:a16="http://schemas.microsoft.com/office/drawing/2014/main" id="{C695549C-C3E0-E792-AD11-203F5F1926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20150" y="104790"/>
            <a:ext cx="3150279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kern="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等线 Light" panose="02010600030101010101" pitchFamily="2" charset="-122"/>
              </a:rPr>
              <a:t>Liang_Supplementary Video S2</a:t>
            </a:r>
          </a:p>
        </p:txBody>
      </p:sp>
    </p:spTree>
    <p:extLst>
      <p:ext uri="{BB962C8B-B14F-4D97-AF65-F5344CB8AC3E}">
        <p14:creationId xmlns:p14="http://schemas.microsoft.com/office/powerpoint/2010/main" val="21017206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CB3434A5-8E69-0F29-76FF-45A6F7F2DB8D}"/>
              </a:ext>
            </a:extLst>
          </p:cNvPr>
          <p:cNvSpPr txBox="1"/>
          <p:nvPr/>
        </p:nvSpPr>
        <p:spPr>
          <a:xfrm>
            <a:off x="1726849" y="4435253"/>
            <a:ext cx="873830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b="1" kern="100" dirty="0">
                <a:solidFill>
                  <a:srgbClr val="0D0D0D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Video S3</a:t>
            </a:r>
            <a:r>
              <a:rPr lang="en-US" altLang="zh-CN" b="1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: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UBB4A promotes EB3 tracked </a:t>
            </a:r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crotubule assembly at a slower growth rate. </a:t>
            </a:r>
            <a:endParaRPr lang="en-US" altLang="zh-CN" b="1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Representative videos of the EB3 tracking behavior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CN" sz="1800" kern="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quantification of EB3 comet velocity 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at microtubule plus-ends in Hela cells expressing </a:t>
            </a:r>
            <a:r>
              <a:rPr lang="en-US" altLang="zh-CN" kern="100" dirty="0">
                <a:solidFill>
                  <a:srgbClr val="0D0D0D"/>
                </a:solidFill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siTUBB4As or siCtrl</a:t>
            </a:r>
            <a:r>
              <a:rPr lang="en-US" altLang="zh-CN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</a:rPr>
              <a:t>. </a:t>
            </a: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1476F640-26FE-8099-E96C-5863D0A69F70}"/>
              </a:ext>
            </a:extLst>
          </p:cNvPr>
          <p:cNvGrpSpPr/>
          <p:nvPr/>
        </p:nvGrpSpPr>
        <p:grpSpPr>
          <a:xfrm>
            <a:off x="1726849" y="1626417"/>
            <a:ext cx="8738302" cy="2622409"/>
            <a:chOff x="456760" y="1181006"/>
            <a:chExt cx="8738302" cy="2622409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41DBCF01-F3C2-959F-A10E-9AF3511938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20179" b="20000"/>
            <a:stretch/>
          </p:blipFill>
          <p:spPr>
            <a:xfrm>
              <a:off x="4849869" y="1643415"/>
              <a:ext cx="2160000" cy="21600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B0A52BCC-844A-6F13-8A9A-5B00BFF16A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5893" t="12857" r="14286" b="7143"/>
            <a:stretch/>
          </p:blipFill>
          <p:spPr>
            <a:xfrm>
              <a:off x="479485" y="1643415"/>
              <a:ext cx="2160000" cy="2160000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274AB5DA-C204-1B99-EC6F-9AD3B0962D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2143" r="20179" b="17857"/>
            <a:stretch/>
          </p:blipFill>
          <p:spPr>
            <a:xfrm>
              <a:off x="7035062" y="1643415"/>
              <a:ext cx="2160000" cy="2160000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287DA8C7-FF6E-DE59-66A0-4EABD92602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5804" t="3214" r="4375" b="16786"/>
            <a:stretch/>
          </p:blipFill>
          <p:spPr>
            <a:xfrm>
              <a:off x="2664677" y="1643415"/>
              <a:ext cx="2160000" cy="2160000"/>
            </a:xfrm>
            <a:prstGeom prst="rect">
              <a:avLst/>
            </a:prstGeom>
          </p:spPr>
        </p:pic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FAEB203D-A18E-CCF1-7E93-4ABB25B23A48}"/>
                </a:ext>
              </a:extLst>
            </p:cNvPr>
            <p:cNvGrpSpPr/>
            <p:nvPr/>
          </p:nvGrpSpPr>
          <p:grpSpPr>
            <a:xfrm>
              <a:off x="474624" y="1181006"/>
              <a:ext cx="2160000" cy="402772"/>
              <a:chOff x="282713" y="1173268"/>
              <a:chExt cx="2160000" cy="402772"/>
            </a:xfrm>
          </p:grpSpPr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6AAB9258-FFA0-7CA6-F3B3-68A4F95E7579}"/>
                  </a:ext>
                </a:extLst>
              </p:cNvPr>
              <p:cNvSpPr txBox="1"/>
              <p:nvPr/>
            </p:nvSpPr>
            <p:spPr>
              <a:xfrm>
                <a:off x="1020312" y="1189988"/>
                <a:ext cx="71045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siCtrl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CAA05D09-6BD5-F643-1520-F34ACEF191CD}"/>
                  </a:ext>
                </a:extLst>
              </p:cNvPr>
              <p:cNvSpPr/>
              <p:nvPr/>
            </p:nvSpPr>
            <p:spPr>
              <a:xfrm>
                <a:off x="282713" y="1173268"/>
                <a:ext cx="2160000" cy="4027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8049FCCC-448A-7FEC-EF7A-A5D81251FB1A}"/>
                </a:ext>
              </a:extLst>
            </p:cNvPr>
            <p:cNvGrpSpPr/>
            <p:nvPr/>
          </p:nvGrpSpPr>
          <p:grpSpPr>
            <a:xfrm>
              <a:off x="2657674" y="1181006"/>
              <a:ext cx="2160000" cy="402772"/>
              <a:chOff x="2819010" y="1156548"/>
              <a:chExt cx="2160000" cy="402772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B2E75A67-1C3C-4A6C-43C5-B34DE627D316}"/>
                  </a:ext>
                </a:extLst>
              </p:cNvPr>
              <p:cNvSpPr txBox="1"/>
              <p:nvPr/>
            </p:nvSpPr>
            <p:spPr>
              <a:xfrm>
                <a:off x="3199521" y="1173268"/>
                <a:ext cx="14542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siTUBB4A-1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884184FB-2D03-791E-F7C9-10FB31709ABC}"/>
                  </a:ext>
                </a:extLst>
              </p:cNvPr>
              <p:cNvSpPr/>
              <p:nvPr/>
            </p:nvSpPr>
            <p:spPr>
              <a:xfrm>
                <a:off x="2819010" y="1156548"/>
                <a:ext cx="2160000" cy="4027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1F6767AA-83EC-C25B-CAFC-686B46CBC38B}"/>
                </a:ext>
              </a:extLst>
            </p:cNvPr>
            <p:cNvGrpSpPr/>
            <p:nvPr/>
          </p:nvGrpSpPr>
          <p:grpSpPr>
            <a:xfrm>
              <a:off x="4840724" y="1181006"/>
              <a:ext cx="2160000" cy="402772"/>
              <a:chOff x="5363150" y="1173268"/>
              <a:chExt cx="2160000" cy="402772"/>
            </a:xfrm>
          </p:grpSpPr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9B20DB3B-5EFF-7FE2-3C53-AC086998F042}"/>
                  </a:ext>
                </a:extLst>
              </p:cNvPr>
              <p:cNvSpPr txBox="1"/>
              <p:nvPr/>
            </p:nvSpPr>
            <p:spPr>
              <a:xfrm>
                <a:off x="5743661" y="1189988"/>
                <a:ext cx="14542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siTUBB4A-2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矩形 20">
                <a:extLst>
                  <a:ext uri="{FF2B5EF4-FFF2-40B4-BE49-F238E27FC236}">
                    <a16:creationId xmlns:a16="http://schemas.microsoft.com/office/drawing/2014/main" id="{8AC118A7-254D-FA59-A1E3-2AE94D5849B9}"/>
                  </a:ext>
                </a:extLst>
              </p:cNvPr>
              <p:cNvSpPr/>
              <p:nvPr/>
            </p:nvSpPr>
            <p:spPr>
              <a:xfrm>
                <a:off x="5363150" y="1173268"/>
                <a:ext cx="2160000" cy="4027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60F969D8-0AF5-0669-093A-360F54901407}"/>
                </a:ext>
              </a:extLst>
            </p:cNvPr>
            <p:cNvGrpSpPr/>
            <p:nvPr/>
          </p:nvGrpSpPr>
          <p:grpSpPr>
            <a:xfrm>
              <a:off x="7023773" y="1181006"/>
              <a:ext cx="2160000" cy="402772"/>
              <a:chOff x="7328151" y="1173268"/>
              <a:chExt cx="2160000" cy="402772"/>
            </a:xfrm>
          </p:grpSpPr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922AA793-861A-A2DF-4080-8A13E7BF8E87}"/>
                  </a:ext>
                </a:extLst>
              </p:cNvPr>
              <p:cNvSpPr txBox="1"/>
              <p:nvPr/>
            </p:nvSpPr>
            <p:spPr>
              <a:xfrm>
                <a:off x="7708662" y="1189988"/>
                <a:ext cx="14542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siTUBB4A-3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矩形 22">
                <a:extLst>
                  <a:ext uri="{FF2B5EF4-FFF2-40B4-BE49-F238E27FC236}">
                    <a16:creationId xmlns:a16="http://schemas.microsoft.com/office/drawing/2014/main" id="{AD55F038-7F47-9FAD-CE4B-60E8709B016F}"/>
                  </a:ext>
                </a:extLst>
              </p:cNvPr>
              <p:cNvSpPr/>
              <p:nvPr/>
            </p:nvSpPr>
            <p:spPr>
              <a:xfrm>
                <a:off x="7328151" y="1173268"/>
                <a:ext cx="2160000" cy="4027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25F48986-E462-2F6C-2AA2-D2F5B64BEEB7}"/>
                </a:ext>
              </a:extLst>
            </p:cNvPr>
            <p:cNvSpPr txBox="1"/>
            <p:nvPr/>
          </p:nvSpPr>
          <p:spPr>
            <a:xfrm>
              <a:off x="456760" y="1643415"/>
              <a:ext cx="13131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B3-eGFP</a:t>
              </a:r>
              <a:endParaRPr kumimoji="1" lang="zh-CN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直线连接符 24">
              <a:extLst>
                <a:ext uri="{FF2B5EF4-FFF2-40B4-BE49-F238E27FC236}">
                  <a16:creationId xmlns:a16="http://schemas.microsoft.com/office/drawing/2014/main" id="{8B1938DB-30A2-69AD-3582-8F96AFCDA307}"/>
                </a:ext>
              </a:extLst>
            </p:cNvPr>
            <p:cNvCxnSpPr/>
            <p:nvPr/>
          </p:nvCxnSpPr>
          <p:spPr>
            <a:xfrm>
              <a:off x="8665213" y="3680154"/>
              <a:ext cx="3888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C9F9E90D-8284-BC4C-CBBA-CCF220102A85}"/>
                </a:ext>
              </a:extLst>
            </p:cNvPr>
            <p:cNvSpPr txBox="1"/>
            <p:nvPr/>
          </p:nvSpPr>
          <p:spPr>
            <a:xfrm>
              <a:off x="8497367" y="3372377"/>
              <a:ext cx="6864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l-GR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μm</a:t>
              </a:r>
              <a:endParaRPr kumimoji="1"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Rectangle 2">
            <a:extLst>
              <a:ext uri="{FF2B5EF4-FFF2-40B4-BE49-F238E27FC236}">
                <a16:creationId xmlns:a16="http://schemas.microsoft.com/office/drawing/2014/main" id="{26E8D508-517F-67AE-73E8-56F4D7BD35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20150" y="104790"/>
            <a:ext cx="3150279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kern="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等线 Light" panose="02010600030101010101" pitchFamily="2" charset="-122"/>
              </a:rPr>
              <a:t>Liang_Supplementary Video S3</a:t>
            </a:r>
          </a:p>
        </p:txBody>
      </p:sp>
    </p:spTree>
    <p:extLst>
      <p:ext uri="{BB962C8B-B14F-4D97-AF65-F5344CB8AC3E}">
        <p14:creationId xmlns:p14="http://schemas.microsoft.com/office/powerpoint/2010/main" val="2643195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6</TotalTime>
  <Words>165</Words>
  <Application>Microsoft Office PowerPoint</Application>
  <PresentationFormat>宽屏</PresentationFormat>
  <Paragraphs>24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梁 晓琳</dc:creator>
  <cp:lastModifiedBy>猛 贡</cp:lastModifiedBy>
  <cp:revision>64</cp:revision>
  <dcterms:created xsi:type="dcterms:W3CDTF">2023-02-08T07:59:53Z</dcterms:created>
  <dcterms:modified xsi:type="dcterms:W3CDTF">2024-03-16T07:55:51Z</dcterms:modified>
</cp:coreProperties>
</file>